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55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2611F2-F892-44A0-93C8-B949927D8E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BB86FE0-9192-4FB2-9D18-1BF9869E40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D7C7EB9-1611-4E2A-8F9E-E1104B893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A09D011-E325-4042-BD8A-C18BB7D9F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3FB433-B9E7-42F8-AA6A-67A44959A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1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F77003-89B4-4529-BC85-FDE1210FF1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3740F27-A286-4AFC-8227-11EC0199C1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39BD59B-BAD2-45CE-AD41-59BEF9D91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792FA9-C2EC-4715-8AD8-8417CED8E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446B494-8906-4AB2-917A-2DEB93AB3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30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657EE84-9E6B-4EEC-9445-F983E9320F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ED7DE84-7BF0-4EF7-8D98-6D7B3D241D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30A392-E8A3-4200-BA73-9AC62EBE9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C695CFF-4E8E-4F0A-B923-9EDBB2DA0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94CACDE-3774-43DC-8F9B-F125D15A3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295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FCCD3A-B17F-419B-93D5-2E9B205999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04EC5C5-0DA6-4590-98F4-D8494587BF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FCDD547-82C5-4A61-97F4-84F2460FF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BEB0CC7-A5DC-4978-8E4C-48650CFFC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032A601-8018-4D6F-869C-67814870A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456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A01BEB-5197-4560-8AE9-58A2BD34A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FCEA85C-D49A-479D-B102-2FA9046E49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CB3D9AF-D1BB-4091-A53F-FD81BBBD3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1992BB5-71D3-4C82-9688-6213228E5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84C3B7D-60F5-40C9-93F9-32B5B1B04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831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4A71424-39E4-46FF-BBD4-945A0D06AC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A0A1B55-A4B7-4F1A-BFB9-F8FF8A917A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9241EC5-E210-49DB-9C73-1A6CF91A93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3EEC3A7-B88E-4AB3-8C87-933CFD601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B8CCDED-0F74-49DF-AA78-E2AFBC6C0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6C9ADC9-0E6F-475F-B64E-C479FF817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084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ABA89DE-EA7E-4903-995D-5243DF1C8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BBF55AC-FA37-410F-9990-7109C36B3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D0DECF9-B588-41BE-9E94-5FC74653B4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C69EC13-CB32-4836-AFFE-A2AD10ED01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25A427C-A67B-43BC-81F2-0CB629DB41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B3E9A45-28A1-4C74-8356-5F9B3AD5C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1C42B4B-D21D-4F61-9737-0EFC31A5D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66C3C1B-EF13-44B4-ABBA-74F76F5F8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377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198B6E-577A-4FBA-A6AD-764C63E4F0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CC051BD-F680-483D-B57A-42C4E2C2B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424DC5D-F028-484C-97FE-F777AA9177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3BF75A2-C3FF-472D-94F2-51574FD44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185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C73FB74-A46F-49A2-9862-688AEC66E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0714FA-5643-45F7-9965-07C6FF54B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9AC1B21-82E8-49C3-A1F1-05B38C723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184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C7C5A0-FA5C-4389-A5FC-6E6E0591F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1258100-91AB-4B88-BE85-D35CBFDF0F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B076C32-7A65-4417-AB03-34C78DEA25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8987703-F590-46B5-A7E2-E75C865C9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BBCE74C-0455-4D13-BF97-4187B3CB7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6EF6D7B-D098-4D84-BCCA-B91B03490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206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7432416-21AE-48DB-81F6-13115F9277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952B892-87FB-49AA-BCF6-746A198A9A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27CC09B-155D-4EFF-A10C-A36846A239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5A76F8B-84FA-489F-BB97-117EFF94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FC7C582-2E2F-4A1E-A832-07FBDC379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02B5AA1-560E-42C4-9B83-889C43738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234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29AD06F-0988-4B34-8249-3FA12E9E23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3C4F346-A9AA-4E3C-A650-8F4E8B6619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F1D804-7C81-43DA-9F60-EB89840647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17133-E566-4F1C-881D-DF5415CC69BB}" type="datetimeFigureOut">
              <a:rPr lang="en-US" smtClean="0"/>
              <a:t>7/6/2023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2A710FA-B1E9-48E6-B6D3-2A99896DF1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832DAC6-0D68-45D4-A763-2D6CCD89D2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EE6D2E-0DA2-46B8-922F-C017547FC6E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391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ottotitolo 2">
            <a:extLst>
              <a:ext uri="{FF2B5EF4-FFF2-40B4-BE49-F238E27FC236}">
                <a16:creationId xmlns:a16="http://schemas.microsoft.com/office/drawing/2014/main" id="{93E0DB0D-4CDC-430E-A2B5-2E7A8C6B40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410043" y="371158"/>
            <a:ext cx="11373502" cy="1030922"/>
          </a:xfrm>
        </p:spPr>
        <p:txBody>
          <a:bodyPr anchor="ctr">
            <a:normAutofit/>
          </a:bodyPr>
          <a:lstStyle/>
          <a:p>
            <a:pPr algn="l"/>
            <a:r>
              <a:rPr lang="en-GB" sz="1600" b="1" dirty="0">
                <a:latin typeface="Palatino Linotype" panose="02040502050505030304" pitchFamily="18" charset="0"/>
              </a:rPr>
              <a:t>Figure S2: </a:t>
            </a:r>
            <a:r>
              <a:rPr lang="en-GB" sz="1600" dirty="0">
                <a:latin typeface="Palatino Linotype" panose="02040502050505030304" pitchFamily="18" charset="0"/>
              </a:rPr>
              <a:t>BMs ranking based on the level of implementation as perceived by all stakeholders.</a:t>
            </a:r>
          </a:p>
        </p:txBody>
      </p:sp>
      <p:graphicFrame>
        <p:nvGraphicFramePr>
          <p:cNvPr id="7" name="Oggetto 6">
            <a:extLst>
              <a:ext uri="{FF2B5EF4-FFF2-40B4-BE49-F238E27FC236}">
                <a16:creationId xmlns:a16="http://schemas.microsoft.com/office/drawing/2014/main" id="{FF45CA2E-71AE-4540-82A1-62B23B502D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4485196"/>
              </p:ext>
            </p:extLst>
          </p:nvPr>
        </p:nvGraphicFramePr>
        <p:xfrm>
          <a:off x="1065213" y="1143000"/>
          <a:ext cx="9913937" cy="5492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10" r:id="rId3" imgW="9019239" imgH="4991694" progId="Prism10.Document">
                  <p:embed/>
                </p:oleObj>
              </mc:Choice>
              <mc:Fallback>
                <p:oleObj name="Prism 10" r:id="rId3" imgW="9019239" imgH="4991694" progId="Prism10.Document">
                  <p:embed/>
                  <p:pic>
                    <p:nvPicPr>
                      <p:cNvPr id="2" name="Oggetto 1">
                        <a:extLst>
                          <a:ext uri="{FF2B5EF4-FFF2-40B4-BE49-F238E27FC236}">
                            <a16:creationId xmlns:a16="http://schemas.microsoft.com/office/drawing/2014/main" id="{42E9DB47-B55D-41C4-8905-A791F82581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65213" y="1143000"/>
                        <a:ext cx="9913937" cy="5492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515139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1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GraphPad Prism Projec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5</cp:revision>
  <dcterms:created xsi:type="dcterms:W3CDTF">2023-05-24T15:57:23Z</dcterms:created>
  <dcterms:modified xsi:type="dcterms:W3CDTF">2023-07-06T14:15:07Z</dcterms:modified>
</cp:coreProperties>
</file>